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2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AFCABA9-5C13-417A-986D-60E08093E66B}"/>
              </a:ext>
            </a:extLst>
          </p:cNvPr>
          <p:cNvSpPr txBox="1"/>
          <p:nvPr/>
        </p:nvSpPr>
        <p:spPr>
          <a:xfrm>
            <a:off x="165372" y="2669"/>
            <a:ext cx="69941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ar graph showing the distribution of plasma exosome proteins identified using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irectDI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alysis in different exosome extraction methods UC and UF. UC: ultracentrifugation, UF: ultrafiltrati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:a16="http://schemas.microsoft.com/office/drawing/2014/main" id="{607C0AA3-A053-4BBC-9790-6269287A27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673" y="422315"/>
            <a:ext cx="5325372" cy="3801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4281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3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6:37Z</dcterms:modified>
</cp:coreProperties>
</file>